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1092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937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870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398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577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002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358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588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726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901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831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081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6BBAC5-9844-4696-94B5-F408654ACDF9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7EF90-2A4F-4344-9823-ACCD16251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381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7" t="15859" r="4658" b="6930"/>
          <a:stretch/>
        </p:blipFill>
        <p:spPr bwMode="auto">
          <a:xfrm>
            <a:off x="152400" y="605189"/>
            <a:ext cx="3836184" cy="24057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4493" y="2032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52400" y="3010932"/>
            <a:ext cx="4724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xyge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sumption rates (OCR) of 4 TIL lines on day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4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REP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termin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sing a Seahorse XP96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oanalyze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hows no difference between the 2 devices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3604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35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orget,Marie Andree</dc:creator>
  <cp:lastModifiedBy>Haymaker,Cara</cp:lastModifiedBy>
  <cp:revision>3</cp:revision>
  <dcterms:created xsi:type="dcterms:W3CDTF">2015-04-22T20:53:15Z</dcterms:created>
  <dcterms:modified xsi:type="dcterms:W3CDTF">2015-05-06T14:49:32Z</dcterms:modified>
</cp:coreProperties>
</file>